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7" r:id="rId2"/>
    <p:sldId id="276" r:id="rId3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2878"/>
    <p:restoredTop sz="94660"/>
  </p:normalViewPr>
  <p:slideViewPr>
    <p:cSldViewPr snapToGrid="0">
      <p:cViewPr varScale="1">
        <p:scale>
          <a:sx n="84" d="100"/>
          <a:sy n="84" d="100"/>
        </p:scale>
        <p:origin x="2832" y="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-2256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B7706-B72D-40A4-8649-1309158D8033}" type="datetimeFigureOut">
              <a:rPr lang="en-US" smtClean="0"/>
              <a:t>30-Dec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437D91-3F53-4A9E-8809-837E706A93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16004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B7706-B72D-40A4-8649-1309158D8033}" type="datetimeFigureOut">
              <a:rPr lang="en-US" smtClean="0"/>
              <a:t>30-Dec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437D91-3F53-4A9E-8809-837E706A93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58429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B7706-B72D-40A4-8649-1309158D8033}" type="datetimeFigureOut">
              <a:rPr lang="en-US" smtClean="0"/>
              <a:t>30-Dec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437D91-3F53-4A9E-8809-837E706A93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46294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B7706-B72D-40A4-8649-1309158D8033}" type="datetimeFigureOut">
              <a:rPr lang="en-US" smtClean="0"/>
              <a:t>30-Dec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437D91-3F53-4A9E-8809-837E706A93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87361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B7706-B72D-40A4-8649-1309158D8033}" type="datetimeFigureOut">
              <a:rPr lang="en-US" smtClean="0"/>
              <a:t>30-Dec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437D91-3F53-4A9E-8809-837E706A93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38201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B7706-B72D-40A4-8649-1309158D8033}" type="datetimeFigureOut">
              <a:rPr lang="en-US" smtClean="0"/>
              <a:t>30-Dec-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437D91-3F53-4A9E-8809-837E706A93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35895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B7706-B72D-40A4-8649-1309158D8033}" type="datetimeFigureOut">
              <a:rPr lang="en-US" smtClean="0"/>
              <a:t>30-Dec-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437D91-3F53-4A9E-8809-837E706A93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65672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B7706-B72D-40A4-8649-1309158D8033}" type="datetimeFigureOut">
              <a:rPr lang="en-US" smtClean="0"/>
              <a:t>30-Dec-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437D91-3F53-4A9E-8809-837E706A93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97169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B7706-B72D-40A4-8649-1309158D8033}" type="datetimeFigureOut">
              <a:rPr lang="en-US" smtClean="0"/>
              <a:t>30-Dec-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437D91-3F53-4A9E-8809-837E706A93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22334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B7706-B72D-40A4-8649-1309158D8033}" type="datetimeFigureOut">
              <a:rPr lang="en-US" smtClean="0"/>
              <a:t>30-Dec-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437D91-3F53-4A9E-8809-837E706A93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38851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B7706-B72D-40A4-8649-1309158D8033}" type="datetimeFigureOut">
              <a:rPr lang="en-US" smtClean="0"/>
              <a:t>30-Dec-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437D91-3F53-4A9E-8809-837E706A93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31354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EB7706-B72D-40A4-8649-1309158D8033}" type="datetimeFigureOut">
              <a:rPr lang="en-US" smtClean="0"/>
              <a:t>30-Dec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437D91-3F53-4A9E-8809-837E706A93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54588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46468" y="6669544"/>
            <a:ext cx="6811532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 : Optical Density Data of Strain and Condition Dependence of </a:t>
            </a:r>
            <a:r>
              <a:rPr lang="el-GR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agr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iofilm Enhancement in vitro.</a:t>
            </a:r>
          </a:p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A) Comparison of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g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 biofilm grown with 20% human plasma in TSB + 3% NaCl + 0.05% Dextrose (TNG) versus BHI + 3% NaCl + 0.05% Dextrose (BNG). (B) Comparison of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g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 biofilm grown in TNG with 20% human plasma (left) or without (right). (C) Comparison of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g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rown in TNG with 20% human plasma (left) or without (right). (D) Comparison of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g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rown in TNG with 20% human plasma (left) or without (right). The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g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train is AH1263 and its isogenic deletion mutant is AH1292, and the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g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g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re the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S. aureu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trains 502A and MW2, respectively with their isogenic deletion mutants. Data represent ≥ 3 biological replicates and are expressed as the mean ± SD (* p &lt; 0.05, *** p &lt; 0.001, , **** p &lt; 0.0001, ns = not significant). </a:t>
            </a:r>
          </a:p>
          <a:p>
            <a:pPr algn="just"/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 descr="Application&#10;&#10;Description automatically generated with medium confidence">
            <a:extLst>
              <a:ext uri="{FF2B5EF4-FFF2-40B4-BE49-F238E27FC236}">
                <a16:creationId xmlns:a16="http://schemas.microsoft.com/office/drawing/2014/main" id="{68549C79-2A96-45BF-8B9C-A003746B4D1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2998" y="80010"/>
            <a:ext cx="4372003" cy="66695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907625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scatter chart&#10;&#10;Description automatically generated">
            <a:extLst>
              <a:ext uri="{FF2B5EF4-FFF2-40B4-BE49-F238E27FC236}">
                <a16:creationId xmlns:a16="http://schemas.microsoft.com/office/drawing/2014/main" id="{BE285826-035D-4A0D-8975-F20261ACF0C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6589" y="419858"/>
            <a:ext cx="6464821" cy="329794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9C62DAA-F1C2-4355-8283-FE2B6093E005}"/>
              </a:ext>
            </a:extLst>
          </p:cNvPr>
          <p:cNvSpPr txBox="1"/>
          <p:nvPr/>
        </p:nvSpPr>
        <p:spPr>
          <a:xfrm>
            <a:off x="-1" y="4267365"/>
            <a:ext cx="6858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: Infection by </a:t>
            </a:r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agr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2 is also not more pathogenic. </a:t>
            </a:r>
          </a:p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acterial burden (CFUs) on implanted catheter (a) and surrounding abscess (b) on day 7 post-infection. Data are the average of two experiments with a cumulative total of n = 10-11 mice per group and are expressed as the mean ± SEM (p-values: *p&lt;0.05).</a:t>
            </a:r>
          </a:p>
        </p:txBody>
      </p:sp>
    </p:spTree>
    <p:extLst>
      <p:ext uri="{BB962C8B-B14F-4D97-AF65-F5344CB8AC3E}">
        <p14:creationId xmlns:p14="http://schemas.microsoft.com/office/powerpoint/2010/main" val="11188578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9605</TotalTime>
  <Words>266</Words>
  <Application>Microsoft Office PowerPoint</Application>
  <PresentationFormat>On-screen Show (4:3)</PresentationFormat>
  <Paragraphs>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UNM HS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H</dc:creator>
  <cp:lastModifiedBy>Seth Daly</cp:lastModifiedBy>
  <cp:revision>264</cp:revision>
  <cp:lastPrinted>2016-11-01T19:15:37Z</cp:lastPrinted>
  <dcterms:created xsi:type="dcterms:W3CDTF">2016-05-20T17:23:24Z</dcterms:created>
  <dcterms:modified xsi:type="dcterms:W3CDTF">2021-12-30T12:35:06Z</dcterms:modified>
</cp:coreProperties>
</file>